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5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799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711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425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511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67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727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800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423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792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331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94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DA6D9-3D17-4C3E-A45C-75F8B31B6D48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496A7-306D-4D20-8A2A-BEB714BBF0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304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95400" y="5248870"/>
            <a:ext cx="7239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thern analysis of representative T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genic lines from different silencing constructs showing variable number of insertion sites. The 5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 of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was used as probe.</a:t>
            </a:r>
          </a:p>
        </p:txBody>
      </p:sp>
      <p:pic>
        <p:nvPicPr>
          <p:cNvPr id="3" name="Picture 2" descr="G:\Southern2 fig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9400" y="1447800"/>
            <a:ext cx="3429000" cy="31845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89786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3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Kajla</dc:creator>
  <cp:lastModifiedBy>Sachin Kajla</cp:lastModifiedBy>
  <cp:revision>12</cp:revision>
  <dcterms:created xsi:type="dcterms:W3CDTF">2016-12-29T10:21:56Z</dcterms:created>
  <dcterms:modified xsi:type="dcterms:W3CDTF">2017-07-03T12:01:01Z</dcterms:modified>
</cp:coreProperties>
</file>